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1" r:id="rId5"/>
    <p:sldId id="259" r:id="rId6"/>
    <p:sldId id="258" r:id="rId7"/>
    <p:sldId id="257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38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377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322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05741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842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069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0436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75380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081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453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75433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38768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11C787-2CDF-4ECE-9FC6-6C1C7008F069}" type="datetimeFigureOut">
              <a:rPr lang="en-US" smtClean="0"/>
              <a:t>8/2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A4BD5F-585F-4EF1-8883-DA5EC47B8D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8101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andreas.koutroulis@odont.uio.no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74776" y="1386713"/>
            <a:ext cx="10515600" cy="4351338"/>
          </a:xfrm>
        </p:spPr>
        <p:txBody>
          <a:bodyPr>
            <a:normAutofit/>
          </a:bodyPr>
          <a:lstStyle/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20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rface characteristics and bacterial adhesion of endodontic </a:t>
            </a:r>
            <a:r>
              <a:rPr lang="en-US" sz="20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ments </a:t>
            </a:r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6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inical Oral Investigations</a:t>
            </a:r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outroulis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.V. </a:t>
            </a:r>
            <a:r>
              <a:rPr lang="en-US" sz="1400" dirty="0" err="1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ukke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Ørstavik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pralos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J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milleri,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.T.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nde</a:t>
            </a:r>
            <a:endParaRPr lang="nb-NO" sz="14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>
              <a:lnSpc>
                <a:spcPct val="150000"/>
              </a:lnSpc>
              <a:buNone/>
            </a:pPr>
            <a:r>
              <a:rPr lang="en-US" sz="1200" dirty="0">
                <a:latin typeface="Times New Roman" panose="02020603050405020304" pitchFamily="18" charset="0"/>
              </a:rPr>
              <a:t>Section of Endodontics, Institute of Clinical Dentistry, Faculty of Dentistry, University of </a:t>
            </a:r>
            <a:r>
              <a:rPr lang="en-US" sz="1200" dirty="0" smtClean="0">
                <a:latin typeface="Times New Roman" panose="02020603050405020304" pitchFamily="18" charset="0"/>
              </a:rPr>
              <a:t>Oslo, Oslo, Norway</a:t>
            </a:r>
            <a:endParaRPr lang="nb-NO" sz="1200" dirty="0"/>
          </a:p>
          <a:p>
            <a:pPr marL="0" indent="0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-mail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ress: </a:t>
            </a:r>
            <a:r>
              <a:rPr lang="en-US" sz="1200" u="sng" dirty="0">
                <a:solidFill>
                  <a:srgbClr val="0563C1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  <a:hlinkClick r:id="rId2"/>
              </a:rPr>
              <a:t>andreas.koutroulis@odont.uio.no</a:t>
            </a:r>
            <a:endParaRPr lang="nb-NO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800"/>
              </a:spcAft>
            </a:pPr>
            <a:endParaRPr lang="nb-NO" sz="2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1287850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619767" y="1273996"/>
            <a:ext cx="10429874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nline Resource 3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ean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standard deviation of bacterial adhesion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pon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aterial surfaces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fter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 h-agitation period at 37 °C in an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terococcus </a:t>
            </a:r>
            <a:r>
              <a:rPr lang="en-US" sz="1200" i="1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ecalis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inoculum. Values are presented per material, immersion liquid (water or FBS) and immersion period (1, 7 or 28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ys). Sterile membrane filters cut to the same diameter (9 mm) as the material specimens served as positive control. </a:t>
            </a:r>
            <a:r>
              <a:rPr lang="en-US" sz="120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d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horizontally, different superscript letters indicate statistically significant differences between different aging periods and immersion solutions within the same material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&lt;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5). Read vertically, different capital letters show statistically significant difference among materials for the exact same conditions of testing (aging period and immersion solution) (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0.05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Asterisks indicate statically significant difference from the positive control (</a:t>
            </a:r>
            <a:r>
              <a:rPr lang="en-US" sz="1200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5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nb-NO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nb-NO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 confocal microscope images of bacterial adhesion on TZ-base an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dentine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amples immersed in water for 1, 7 or 28 days before testing </a:t>
            </a:r>
            <a:r>
              <a:rPr lang="nb-NO" sz="1200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endParaRPr lang="nb-NO" sz="12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37347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4374013"/>
              </p:ext>
            </p:extLst>
          </p:nvPr>
        </p:nvGraphicFramePr>
        <p:xfrm>
          <a:off x="2577423" y="1408621"/>
          <a:ext cx="6585082" cy="4090024"/>
        </p:xfrm>
        <a:graphic>
          <a:graphicData uri="http://schemas.openxmlformats.org/drawingml/2006/table">
            <a:tbl>
              <a:tblPr firstRow="1" firstCol="1" bandRow="1"/>
              <a:tblGrid>
                <a:gridCol w="975577">
                  <a:extLst>
                    <a:ext uri="{9D8B030D-6E8A-4147-A177-3AD203B41FA5}">
                      <a16:colId xmlns:a16="http://schemas.microsoft.com/office/drawing/2014/main" val="1550926532"/>
                    </a:ext>
                  </a:extLst>
                </a:gridCol>
                <a:gridCol w="975577">
                  <a:extLst>
                    <a:ext uri="{9D8B030D-6E8A-4147-A177-3AD203B41FA5}">
                      <a16:colId xmlns:a16="http://schemas.microsoft.com/office/drawing/2014/main" val="2145388024"/>
                    </a:ext>
                  </a:extLst>
                </a:gridCol>
                <a:gridCol w="845347">
                  <a:extLst>
                    <a:ext uri="{9D8B030D-6E8A-4147-A177-3AD203B41FA5}">
                      <a16:colId xmlns:a16="http://schemas.microsoft.com/office/drawing/2014/main" val="2067734133"/>
                    </a:ext>
                  </a:extLst>
                </a:gridCol>
                <a:gridCol w="935606">
                  <a:extLst>
                    <a:ext uri="{9D8B030D-6E8A-4147-A177-3AD203B41FA5}">
                      <a16:colId xmlns:a16="http://schemas.microsoft.com/office/drawing/2014/main" val="888579112"/>
                    </a:ext>
                  </a:extLst>
                </a:gridCol>
                <a:gridCol w="955986">
                  <a:extLst>
                    <a:ext uri="{9D8B030D-6E8A-4147-A177-3AD203B41FA5}">
                      <a16:colId xmlns:a16="http://schemas.microsoft.com/office/drawing/2014/main" val="1574014074"/>
                    </a:ext>
                  </a:extLst>
                </a:gridCol>
                <a:gridCol w="955986">
                  <a:extLst>
                    <a:ext uri="{9D8B030D-6E8A-4147-A177-3AD203B41FA5}">
                      <a16:colId xmlns:a16="http://schemas.microsoft.com/office/drawing/2014/main" val="3880408557"/>
                    </a:ext>
                  </a:extLst>
                </a:gridCol>
                <a:gridCol w="941003">
                  <a:extLst>
                    <a:ext uri="{9D8B030D-6E8A-4147-A177-3AD203B41FA5}">
                      <a16:colId xmlns:a16="http://schemas.microsoft.com/office/drawing/2014/main" val="657801221"/>
                    </a:ext>
                  </a:extLst>
                </a:gridCol>
              </a:tblGrid>
              <a:tr h="271663">
                <a:tc gridSpan="7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 i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. </a:t>
                      </a:r>
                      <a:r>
                        <a:rPr lang="en-US" sz="1000" b="1" i="1" dirty="0" err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ecalis</a:t>
                      </a: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counts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52734179"/>
                  </a:ext>
                </a:extLst>
              </a:tr>
              <a:tr h="271663">
                <a:tc rowSpan="2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GB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terial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 days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 days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 days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2690948"/>
                  </a:ext>
                </a:extLst>
              </a:tr>
              <a:tr h="271663">
                <a:tc v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ater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BS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ater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BS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Water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BS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6741721"/>
                  </a:ext>
                </a:extLst>
              </a:tr>
              <a:tr h="29882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Z-base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 (11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 (8)</a:t>
                      </a:r>
                      <a:r>
                        <a:rPr lang="en-US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 (4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 (5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05 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1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4 (34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5834039"/>
                  </a:ext>
                </a:extLst>
              </a:tr>
              <a:tr h="29882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Z-bg1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 (7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 (4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 (6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 (5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12 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9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6 (60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0113803"/>
                  </a:ext>
                </a:extLst>
              </a:tr>
              <a:tr h="29882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Z-bg20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 (1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 (7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 (7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 (7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8 (47)</a:t>
                      </a:r>
                      <a:r>
                        <a:rPr lang="en-US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r>
                        <a:rPr lang="el-GR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3 (67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c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3472367"/>
                  </a:ext>
                </a:extLst>
              </a:tr>
              <a:tr h="29882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Z-Ag0.5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 (3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4 (5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 (10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 (4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3 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3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9 (67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81908271"/>
                  </a:ext>
                </a:extLst>
              </a:tr>
              <a:tr h="29882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GB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Z-Ag1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 (6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 (5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 (6)</a:t>
                      </a:r>
                      <a:r>
                        <a:rPr lang="en-US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 (8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9 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54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4 (40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2050380"/>
                  </a:ext>
                </a:extLst>
              </a:tr>
              <a:tr h="298828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TZ-Ag2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 (7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 (3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 (5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 (4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2 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0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6 (55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7927760"/>
                  </a:ext>
                </a:extLst>
              </a:tr>
              <a:tr h="430519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iodentine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2 (46)</a:t>
                      </a:r>
                      <a:r>
                        <a:rPr lang="en-US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a</a:t>
                      </a:r>
                      <a:r>
                        <a:rPr lang="el-GR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73 (92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1 (21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3 (74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a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52 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3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44 (59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a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0178258"/>
                  </a:ext>
                </a:extLst>
              </a:tr>
              <a:tr h="428625">
                <a:tc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  <a:tabLst>
                          <a:tab pos="1685925" algn="l"/>
                        </a:tabLst>
                      </a:pPr>
                      <a:r>
                        <a:rPr lang="en-US" sz="1000" b="1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IRM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96 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6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</a:t>
                      </a:r>
                      <a:r>
                        <a:rPr lang="en-US" sz="1100" baseline="30000" dirty="0" err="1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,b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4</a:t>
                      </a:r>
                      <a:r>
                        <a:rPr lang="en-US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3)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b</a:t>
                      </a:r>
                      <a:r>
                        <a:rPr lang="el-GR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3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44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a,b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2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22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B-b</a:t>
                      </a:r>
                      <a:r>
                        <a:rPr lang="el-GR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*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67</a:t>
                      </a:r>
                      <a:r>
                        <a:rPr lang="en-US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6)</a:t>
                      </a:r>
                      <a:r>
                        <a:rPr lang="en-US" sz="1100" baseline="30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1100" baseline="30000" dirty="0" smtClean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a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54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1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(60)</a:t>
                      </a:r>
                      <a:r>
                        <a:rPr lang="en-US" sz="1100" baseline="3000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-b</a:t>
                      </a:r>
                      <a:endParaRPr lang="nb-NO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33362784"/>
                  </a:ext>
                </a:extLst>
              </a:tr>
              <a:tr h="294607">
                <a:tc gridSpan="7">
                  <a:txBody>
                    <a:bodyPr/>
                    <a:lstStyle/>
                    <a:p>
                      <a:pPr algn="just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ositive Control: </a:t>
                      </a:r>
                      <a:r>
                        <a:rPr lang="en-US" sz="1000" dirty="0"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7 (94)</a:t>
                      </a:r>
                      <a:endParaRPr lang="nb-NO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0748" marR="60748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nb-NO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97825693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2012129" y="1254732"/>
            <a:ext cx="4381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nb-NO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552409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Group 56"/>
          <p:cNvGrpSpPr/>
          <p:nvPr/>
        </p:nvGrpSpPr>
        <p:grpSpPr>
          <a:xfrm>
            <a:off x="2030072" y="975416"/>
            <a:ext cx="6502192" cy="3893068"/>
            <a:chOff x="1670476" y="194580"/>
            <a:chExt cx="6502192" cy="3893068"/>
          </a:xfrm>
        </p:grpSpPr>
        <p:grpSp>
          <p:nvGrpSpPr>
            <p:cNvPr id="35" name="Group 34"/>
            <p:cNvGrpSpPr/>
            <p:nvPr/>
          </p:nvGrpSpPr>
          <p:grpSpPr>
            <a:xfrm>
              <a:off x="1670476" y="194580"/>
              <a:ext cx="6362485" cy="3893068"/>
              <a:chOff x="557251" y="886223"/>
              <a:chExt cx="6362485" cy="3893068"/>
            </a:xfrm>
          </p:grpSpPr>
          <p:sp>
            <p:nvSpPr>
              <p:cNvPr id="11" name="TextBox 10"/>
              <p:cNvSpPr txBox="1"/>
              <p:nvPr/>
            </p:nvSpPr>
            <p:spPr>
              <a:xfrm>
                <a:off x="1450640" y="886223"/>
                <a:ext cx="1811391" cy="274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</a:t>
                </a:r>
                <a:r>
                  <a:rPr lang="nb-NO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>
                <a:off x="3285189" y="886224"/>
                <a:ext cx="1800000" cy="274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 </a:t>
                </a:r>
                <a:r>
                  <a:rPr lang="nb-NO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5108346" y="886223"/>
                <a:ext cx="1794113" cy="2743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8 </a:t>
                </a:r>
                <a:r>
                  <a:rPr lang="nb-NO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s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636913" y="1906732"/>
                <a:ext cx="85496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Z-base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557251" y="3602292"/>
                <a:ext cx="101429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12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Biodentine</a:t>
                </a:r>
                <a:endParaRPr 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" name="Picture 9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50642" y="1145232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27" name="Picture 26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85189" y="1145232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31" name="Picture 3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450642" y="2979291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32" name="Picture 31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285189" y="2979291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19736" y="2979291"/>
                <a:ext cx="1800000" cy="1800000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5119736" y="1145232"/>
                <a:ext cx="1800000" cy="1800000"/>
              </a:xfrm>
              <a:prstGeom prst="rect">
                <a:avLst/>
              </a:prstGeom>
            </p:spPr>
          </p:pic>
        </p:grpSp>
        <p:sp>
          <p:nvSpPr>
            <p:cNvPr id="37" name="TextBox 36"/>
            <p:cNvSpPr txBox="1"/>
            <p:nvPr/>
          </p:nvSpPr>
          <p:spPr>
            <a:xfrm>
              <a:off x="1718851" y="194580"/>
              <a:ext cx="43815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nb-NO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" name="Group 40"/>
            <p:cNvGrpSpPr/>
            <p:nvPr/>
          </p:nvGrpSpPr>
          <p:grpSpPr>
            <a:xfrm>
              <a:off x="3922194" y="2022291"/>
              <a:ext cx="593333" cy="184666"/>
              <a:chOff x="3827764" y="1824843"/>
              <a:chExt cx="593333" cy="184666"/>
            </a:xfrm>
          </p:grpSpPr>
          <p:sp>
            <p:nvSpPr>
              <p:cNvPr id="40" name="TextBox 39"/>
              <p:cNvSpPr txBox="1"/>
              <p:nvPr/>
            </p:nvSpPr>
            <p:spPr>
              <a:xfrm>
                <a:off x="3827764" y="1824843"/>
                <a:ext cx="5933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l-GR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nb-NO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9" name="Straight Connector 38"/>
              <p:cNvCxnSpPr/>
              <p:nvPr/>
            </p:nvCxnSpPr>
            <p:spPr>
              <a:xfrm>
                <a:off x="3835463" y="1999035"/>
                <a:ext cx="4248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2" name="Group 41"/>
            <p:cNvGrpSpPr/>
            <p:nvPr/>
          </p:nvGrpSpPr>
          <p:grpSpPr>
            <a:xfrm>
              <a:off x="5750765" y="2002868"/>
              <a:ext cx="593333" cy="184666"/>
              <a:chOff x="3835462" y="1835127"/>
              <a:chExt cx="593333" cy="184666"/>
            </a:xfrm>
          </p:grpSpPr>
          <p:sp>
            <p:nvSpPr>
              <p:cNvPr id="43" name="TextBox 42"/>
              <p:cNvSpPr txBox="1"/>
              <p:nvPr/>
            </p:nvSpPr>
            <p:spPr>
              <a:xfrm>
                <a:off x="3835462" y="1835127"/>
                <a:ext cx="5933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l-GR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nb-NO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4" name="Straight Connector 43"/>
              <p:cNvCxnSpPr/>
              <p:nvPr/>
            </p:nvCxnSpPr>
            <p:spPr>
              <a:xfrm>
                <a:off x="3835463" y="1999035"/>
                <a:ext cx="4248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5" name="Group 44"/>
            <p:cNvGrpSpPr/>
            <p:nvPr/>
          </p:nvGrpSpPr>
          <p:grpSpPr>
            <a:xfrm>
              <a:off x="7579335" y="2024533"/>
              <a:ext cx="593333" cy="184666"/>
              <a:chOff x="3830786" y="1838137"/>
              <a:chExt cx="593333" cy="184666"/>
            </a:xfrm>
          </p:grpSpPr>
          <p:sp>
            <p:nvSpPr>
              <p:cNvPr id="46" name="TextBox 45"/>
              <p:cNvSpPr txBox="1"/>
              <p:nvPr/>
            </p:nvSpPr>
            <p:spPr>
              <a:xfrm>
                <a:off x="3830786" y="1838137"/>
                <a:ext cx="5933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l-GR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nb-NO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7" name="Straight Connector 46"/>
              <p:cNvCxnSpPr/>
              <p:nvPr/>
            </p:nvCxnSpPr>
            <p:spPr>
              <a:xfrm>
                <a:off x="3835463" y="1999035"/>
                <a:ext cx="4248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8" name="Group 47"/>
            <p:cNvGrpSpPr/>
            <p:nvPr/>
          </p:nvGrpSpPr>
          <p:grpSpPr>
            <a:xfrm>
              <a:off x="3922195" y="3856967"/>
              <a:ext cx="593333" cy="184666"/>
              <a:chOff x="3835463" y="1837652"/>
              <a:chExt cx="593333" cy="184666"/>
            </a:xfrm>
          </p:grpSpPr>
          <p:sp>
            <p:nvSpPr>
              <p:cNvPr id="49" name="TextBox 48"/>
              <p:cNvSpPr txBox="1"/>
              <p:nvPr/>
            </p:nvSpPr>
            <p:spPr>
              <a:xfrm>
                <a:off x="3835463" y="1837652"/>
                <a:ext cx="5933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l-GR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nb-NO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0" name="Straight Connector 49"/>
              <p:cNvCxnSpPr/>
              <p:nvPr/>
            </p:nvCxnSpPr>
            <p:spPr>
              <a:xfrm>
                <a:off x="3835463" y="1999035"/>
                <a:ext cx="4248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1" name="Group 50"/>
            <p:cNvGrpSpPr/>
            <p:nvPr/>
          </p:nvGrpSpPr>
          <p:grpSpPr>
            <a:xfrm>
              <a:off x="5750764" y="3870748"/>
              <a:ext cx="593333" cy="184666"/>
              <a:chOff x="3835462" y="1837652"/>
              <a:chExt cx="593333" cy="184666"/>
            </a:xfrm>
          </p:grpSpPr>
          <p:sp>
            <p:nvSpPr>
              <p:cNvPr id="52" name="TextBox 51"/>
              <p:cNvSpPr txBox="1"/>
              <p:nvPr/>
            </p:nvSpPr>
            <p:spPr>
              <a:xfrm>
                <a:off x="3835462" y="1837652"/>
                <a:ext cx="5933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l-GR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nb-NO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Straight Connector 52"/>
              <p:cNvCxnSpPr/>
              <p:nvPr/>
            </p:nvCxnSpPr>
            <p:spPr>
              <a:xfrm>
                <a:off x="3835463" y="1999035"/>
                <a:ext cx="4248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4" name="Group 53"/>
            <p:cNvGrpSpPr/>
            <p:nvPr/>
          </p:nvGrpSpPr>
          <p:grpSpPr>
            <a:xfrm>
              <a:off x="7579335" y="3868685"/>
              <a:ext cx="593333" cy="184666"/>
              <a:chOff x="3835463" y="1837652"/>
              <a:chExt cx="593333" cy="184666"/>
            </a:xfrm>
          </p:grpSpPr>
          <p:sp>
            <p:nvSpPr>
              <p:cNvPr id="55" name="TextBox 54"/>
              <p:cNvSpPr txBox="1"/>
              <p:nvPr/>
            </p:nvSpPr>
            <p:spPr>
              <a:xfrm>
                <a:off x="3835463" y="1837652"/>
                <a:ext cx="593333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00 </a:t>
                </a:r>
                <a:r>
                  <a:rPr lang="el-GR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nb-NO" sz="600" dirty="0" smtClean="0"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m</a:t>
                </a:r>
                <a:endParaRPr lang="nb-NO" sz="600" dirty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6" name="Straight Connector 55"/>
              <p:cNvCxnSpPr/>
              <p:nvPr/>
            </p:nvCxnSpPr>
            <p:spPr>
              <a:xfrm>
                <a:off x="3835463" y="1999035"/>
                <a:ext cx="424800" cy="0"/>
              </a:xfrm>
              <a:prstGeom prst="line">
                <a:avLst/>
              </a:prstGeom>
              <a:ln w="1270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8273741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E7867A5ACEDE7C46879FD70367F61781" ma:contentTypeVersion="4" ma:contentTypeDescription="Opprett et nytt dokument." ma:contentTypeScope="" ma:versionID="9e8313417880cf27a3849aa4c6395ce7">
  <xsd:schema xmlns:xsd="http://www.w3.org/2001/XMLSchema" xmlns:xs="http://www.w3.org/2001/XMLSchema" xmlns:p="http://schemas.microsoft.com/office/2006/metadata/properties" xmlns:ns2="ae4ed773-a29c-4530-bc0b-fc53d9223a14" targetNamespace="http://schemas.microsoft.com/office/2006/metadata/properties" ma:root="true" ma:fieldsID="63821a45407c7b1a6b10c56f79fe5787" ns2:_="">
    <xsd:import namespace="ae4ed773-a29c-4530-bc0b-fc53d9223a14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e4ed773-a29c-4530-bc0b-fc53d9223a14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nholdstype"/>
        <xsd:element ref="dc:title" minOccurs="0" maxOccurs="1" ma:index="4" ma:displayName="Tit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C3A52A7-ABD1-410B-8E4A-D20AB4BE1DFA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ae4ed773-a29c-4530-bc0b-fc53d9223a14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49D19E9B-7188-4267-A07C-C623A55A3B28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5D399FF5-C39E-41B3-B466-33051CA69E6D}">
  <ds:schemaRefs>
    <ds:schemaRef ds:uri="http://purl.org/dc/terms/"/>
    <ds:schemaRef ds:uri="http://schemas.openxmlformats.org/package/2006/metadata/core-properties"/>
    <ds:schemaRef ds:uri="http://schemas.microsoft.com/office/2006/documentManagement/types"/>
    <ds:schemaRef ds:uri="http://schemas.microsoft.com/office/infopath/2007/PartnerControls"/>
    <ds:schemaRef ds:uri="http://purl.org/dc/elements/1.1/"/>
    <ds:schemaRef ds:uri="http://schemas.microsoft.com/office/2006/metadata/properties"/>
    <ds:schemaRef ds:uri="ae4ed773-a29c-4530-bc0b-fc53d9223a14"/>
    <ds:schemaRef ds:uri="http://www.w3.org/XML/1998/namespace"/>
    <ds:schemaRef ds:uri="http://purl.org/dc/dcmitype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572</TotalTime>
  <Words>468</Words>
  <Application>Microsoft Office PowerPoint</Application>
  <PresentationFormat>Widescreen</PresentationFormat>
  <Paragraphs>8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Universitetet i Oslo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dreas Koutroulis</dc:creator>
  <cp:lastModifiedBy>Andreas Koutroulis</cp:lastModifiedBy>
  <cp:revision>33</cp:revision>
  <dcterms:created xsi:type="dcterms:W3CDTF">2021-01-08T14:50:50Z</dcterms:created>
  <dcterms:modified xsi:type="dcterms:W3CDTF">2022-08-02T14:07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7867A5ACEDE7C46879FD70367F61781</vt:lpwstr>
  </property>
</Properties>
</file>